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C9D97-E077-7B17-F533-2A8F2F84F8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6004F0-B1CE-B2F2-D0B2-2900CE18BA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BA323-C04E-64E4-9CAF-53A1B4FD9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F765AC-EF6F-676B-91A9-CBD24D1F6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36DC8A-D7F9-89D7-AB99-EA579E277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6799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D3526-7290-1DC0-8686-F9D99F4F9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98F62A-6082-0FC4-7CDD-E6297E993B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E1DCEA-E207-351B-61E7-9F212FAAF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77072-D773-9C9E-5C25-46C8414EA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C0F8BA-BAA5-F52D-6191-3E3F84565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967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B482D1-930C-06C6-2469-CCDCBDDA6E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FA5A16-EFE9-043A-0844-AF8909B66C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E8F68C-1218-9AFF-8BA0-A4D189F48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E6D5E7-C6D0-7ABA-DA24-89FEB9CC0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76358-213A-F819-F841-6A977468E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336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73C7B-373E-228A-564C-3934366E1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1B9DF6-7C67-1A3A-9E61-65121FC521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5C869A-DC89-0BCE-BF5F-C078C43B0E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B4676-FCAD-67B2-1238-7F38FC72A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E9BB52-0FD3-970B-BC67-D0E27E556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18532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A8009-1033-6E6A-1DB1-A357ED9B8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CCA19A-33A2-DC1D-F048-C3C054CE58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DBA890-F88D-16FC-4EE5-7769FC258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2E626-8AAB-9531-87F8-87FC0075F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1CC471-C498-F8DF-A3E1-59CB546B4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4456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570AFF-F171-4D94-ECD1-19F288DF9A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279394-2A2B-58AD-CAFA-D3CC4D3220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51A785-E1DE-5BAF-AB33-F70C82A8C9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0012E0-AF45-2552-F91F-A5E3C4CFF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735910-4585-4697-48D4-CC7A6B61B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5FD4F6-47E4-0A71-E7EF-7961606D1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0083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515CFA-BA76-9D94-2925-04EC39E00F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EFA409-7B3F-64ED-55B2-FD145C4C57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3D295D-3CE4-9E2E-EDE1-B8917012D3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723B05-A9FB-D02F-E8EE-08B23A51DB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015B29-9248-0338-C7B6-C1BC02BEE5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F62A58-9DAB-8B20-8AE4-172547597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4111E5-541C-15D0-1A2F-AFE7E1A45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D406B1-EF33-5BCC-4FEC-FE0C6DC11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81058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47E93-0300-7C72-E11D-4323E73C8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CD1A66-E09E-702D-E5BA-F3FECFE14F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3A3389-026E-D5EC-B08E-00B53CF33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488C4F-39DD-06CE-71B6-4B5B264CD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93682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DB8D107-4709-D865-B57F-700F39096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CE1C39-C1ED-A21B-924D-4C33F5A76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CD96B7-5AFF-2210-24BB-51B93855B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67121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6A630-C91C-3CCE-F488-E054699FDC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BA5F3E-39AE-0A2E-6C2B-90F1C130E5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C06AF5-83F0-85C7-6829-9E945E8DB6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D7668E-E49D-5A55-B5D3-AAB5BC124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F275FB-B9A4-338E-8EE5-3DA4107BA9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E59806-0AEB-79AA-A289-90C3275FB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20416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14F8E-63B9-B29E-A0CA-BBB1CE8C3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FCD4CA-6D8D-61EB-8959-E1BB465851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5243EC-1EBD-5AB6-DD14-3FE67B97F1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58B06F-FB57-BA72-0795-2E41270CC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6835C3-EBD5-38B6-B180-186CF24BB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4F8ED2-351D-E50F-8B78-9E29B77D3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8893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0338E45-B087-6371-B629-9B4C0E257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EBF98E-3BFF-1CED-9AD3-7DBAB3CAF8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DFC947-0D75-80A2-B8EE-A2F55DE3E5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8F463-7D01-4396-B181-D1A24663F593}" type="datetimeFigureOut">
              <a:rPr lang="en-GB" smtClean="0"/>
              <a:t>20/02/2024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BEA337-23AB-FD27-877D-A5754A0FDB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94ABE6-933D-0D25-84CD-03C850C029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9B3B47-183E-40E7-B88B-D51FB10E74C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83891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4CCBA71-91C0-EDF1-A55A-C770E949CAE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5910" y="865323"/>
          <a:ext cx="2649537" cy="300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649879" imgH="3003685" progId="Prism10.Document">
                  <p:embed/>
                </p:oleObj>
              </mc:Choice>
              <mc:Fallback>
                <p:oleObj name="Prism 10" r:id="rId2" imgW="2649879" imgH="3003685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4CCBA71-91C0-EDF1-A55A-C770E949CA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5910" y="865323"/>
                        <a:ext cx="2649537" cy="300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7DF2BCD-6DB3-5AA4-B505-9E0049B4E00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6412" y="3685280"/>
          <a:ext cx="2649537" cy="300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649879" imgH="3003685" progId="Prism10.Document">
                  <p:embed/>
                </p:oleObj>
              </mc:Choice>
              <mc:Fallback>
                <p:oleObj name="Prism 10" r:id="rId4" imgW="2649879" imgH="3003685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7DF2BCD-6DB3-5AA4-B505-9E0049B4E0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76412" y="3685280"/>
                        <a:ext cx="2649537" cy="300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1FB4E48-CB53-551B-FAF1-9B0F5B600F2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79942" y="3685280"/>
          <a:ext cx="2649537" cy="300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649879" imgH="3003685" progId="Prism10.Document">
                  <p:embed/>
                </p:oleObj>
              </mc:Choice>
              <mc:Fallback>
                <p:oleObj name="Prism 10" r:id="rId6" imgW="2649879" imgH="3003685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1FB4E48-CB53-551B-FAF1-9B0F5B600F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79942" y="3685280"/>
                        <a:ext cx="2649537" cy="300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788C6A5-9A58-F10A-6FFD-BF5F6C270BD8}"/>
              </a:ext>
            </a:extLst>
          </p:cNvPr>
          <p:cNvSpPr txBox="1"/>
          <p:nvPr/>
        </p:nvSpPr>
        <p:spPr>
          <a:xfrm>
            <a:off x="1774112" y="865323"/>
            <a:ext cx="35445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pCDK1</a:t>
            </a:r>
            <a:r>
              <a:rPr lang="en-GB" b="1" baseline="30000" dirty="0"/>
              <a:t>Y15</a:t>
            </a:r>
            <a:r>
              <a:rPr lang="en-GB" b="1" dirty="0"/>
              <a:t>		           pCHK1</a:t>
            </a:r>
            <a:r>
              <a:rPr lang="en-GB" b="1" baseline="30000" dirty="0"/>
              <a:t>s29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538945-FBD4-24FB-6464-AE233BBAD950}"/>
              </a:ext>
            </a:extLst>
          </p:cNvPr>
          <p:cNvSpPr txBox="1"/>
          <p:nvPr/>
        </p:nvSpPr>
        <p:spPr>
          <a:xfrm rot="16200000">
            <a:off x="-211686" y="1974714"/>
            <a:ext cx="976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OVCAR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66C83A-5C5A-B2A9-DE32-9DCF1993A3C2}"/>
              </a:ext>
            </a:extLst>
          </p:cNvPr>
          <p:cNvSpPr txBox="1"/>
          <p:nvPr/>
        </p:nvSpPr>
        <p:spPr>
          <a:xfrm rot="16200000">
            <a:off x="-468519" y="4638246"/>
            <a:ext cx="1490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/>
              <a:t>MDA-MB-436</a:t>
            </a:r>
            <a:endParaRPr lang="en-GB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6FFB20-2BED-A679-5017-0DC072FFEEE1}"/>
              </a:ext>
            </a:extLst>
          </p:cNvPr>
          <p:cNvSpPr txBox="1"/>
          <p:nvPr/>
        </p:nvSpPr>
        <p:spPr>
          <a:xfrm>
            <a:off x="7393353" y="1357044"/>
            <a:ext cx="3607823" cy="4124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Study of mechanism of action of SRA737 and adavosertib in OVCAR3 and MDA-MB-436 cell lines</a:t>
            </a: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OVCAR3 cells exposed to SF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ncentrations of adavosertib (182 nM), SRA737 (730 nM) and the combination of both drugs at these concentrations for 24 hrs. MDA-MB-436 cells were exposed to  SF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concentrations of adavosertib (546 nM) and SRA737 (1819 nM) and the combination for 24 hrs. Experiment conducted once. </a:t>
            </a:r>
          </a:p>
          <a:p>
            <a:pPr algn="just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uantification of blots in Supplementary Figure 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84E15A-18AD-1E49-CBFD-CB312127EB10}"/>
              </a:ext>
            </a:extLst>
          </p:cNvPr>
          <p:cNvSpPr txBox="1"/>
          <p:nvPr/>
        </p:nvSpPr>
        <p:spPr>
          <a:xfrm>
            <a:off x="4326903" y="1915396"/>
            <a:ext cx="1442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t detected</a:t>
            </a:r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1726232-253B-5FC3-5413-91019CC849A1}"/>
              </a:ext>
            </a:extLst>
          </p:cNvPr>
          <p:cNvSpPr txBox="1"/>
          <p:nvPr/>
        </p:nvSpPr>
        <p:spPr>
          <a:xfrm>
            <a:off x="8416031" y="6178858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2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4267560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>The 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dai Banerji</dc:creator>
  <cp:lastModifiedBy>Udai Banerji</cp:lastModifiedBy>
  <cp:revision>2</cp:revision>
  <dcterms:created xsi:type="dcterms:W3CDTF">2024-01-22T19:00:02Z</dcterms:created>
  <dcterms:modified xsi:type="dcterms:W3CDTF">2024-02-20T18:10:35Z</dcterms:modified>
</cp:coreProperties>
</file>